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1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4711" autoAdjust="0"/>
  </p:normalViewPr>
  <p:slideViewPr>
    <p:cSldViewPr showGuides="1">
      <p:cViewPr>
        <p:scale>
          <a:sx n="100" d="100"/>
          <a:sy n="100" d="100"/>
        </p:scale>
        <p:origin x="-294" y="5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4968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68055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89140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4391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7647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8125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5499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7854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301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95233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56643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70DC72-FD1C-464E-A557-D01A4FEC5A06}" type="datetimeFigureOut">
              <a:rPr lang="en-CA" smtClean="0"/>
              <a:t>15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0E990-BF90-4D92-A609-9A9456F694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32741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71600" y="5013176"/>
            <a:ext cx="7200800" cy="36933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just"/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 1.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rosette size in Col-0 and </a:t>
            </a:r>
            <a:r>
              <a:rPr lang="en-CA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graphs of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-0 (bottom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panels) and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top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s)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settes taken 66 DA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eft 2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s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 DA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ight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panels) are presented.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C:\Users\sara\Pictures\Picture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1887" y="260648"/>
            <a:ext cx="4340225" cy="4346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69544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72000" y="5014800"/>
            <a:ext cx="7200000" cy="144000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leaf,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lorescence, and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mass ratios overtime in Col-0 and </a:t>
            </a:r>
            <a:r>
              <a:rPr lang="en-CA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d leaf area per unit plant mass or leaf area ratio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he leaf dry mass per unit plant dry mass or leaf mass ratio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nflorescence mass ratio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root mass ratio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s presented for Col-0 and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asured data for Col-0 (solid lines and filled circles) and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ashed lines and filled squares) was initially taken on 26 DAS for Col-0 and 25 DAS for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llowed by 44, 66, 86 DAS for both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. Values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the mean ± SE and n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plants per line. Measurements of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ich showed a statistically significant difference from Col-0 at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5 are marked with an asterisk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). 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C:\Users\sara.dancom-PC\Desktop\Figure 5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4400" y="259200"/>
            <a:ext cx="5153234" cy="434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051966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72000" y="5014800"/>
            <a:ext cx="7200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: The density distribution of the objectives of the </a:t>
            </a:r>
            <a:r>
              <a:rPr lang="en-CA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f Area Growth Model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four objectives of the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f Area Growth Model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t the weighted absolute difference between modeled and measured leaf area, leaf mass, inflorescence mass, and root mass should be less than or equal to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(Equation 12)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rthermore, a threshold value of 1.5 for the overall differences was applied to select qualified computer simulation results. After applying the threshold, there were 84 identified qualified parameter settings for Col-0 and the 95 parameter settings for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upplementary Tabl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)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 of 200,000 total parameters. Th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ed absolute differences for leaf area, leaf mass, inflorescence mass, and root mass resulting from thes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ed parameter setting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Col-0 and </a:t>
            </a:r>
            <a:r>
              <a:rPr lang="en-CA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s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.</a:t>
            </a:r>
          </a:p>
        </p:txBody>
      </p:sp>
      <p:pic>
        <p:nvPicPr>
          <p:cNvPr id="2050" name="Picture 2" descr="C:\Users\sara\Pictures\Picture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833" y="188640"/>
            <a:ext cx="8105487" cy="434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4654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43508" y="4653136"/>
            <a:ext cx="8856984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: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s between the objectives of the </a:t>
            </a:r>
            <a:r>
              <a:rPr lang="en-CA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f Area Growth Model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four objectives of the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f Area Growth Model described in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are correlated to one another to identify the existence of Pareto fronts. The distributions of the four objectives are presented as density diagrams (diagonal row). With all major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ks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ing close to 0, the distributions indicat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jority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 match with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the four objectives very well. Th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objectives ar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 as contour diagrams (lower triangular) and scatter plots (upper triangular) at different levels of detail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efficient plots show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distinct patterns: (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r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a trade-off between the goodness of fit with respect to measurements of leaf area and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 mass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ulting in a very distinctive Pareto front between these two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bjectives. Th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istence of this trade-off justifies the need to use multi-objective optimization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2) no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r Pareto front can b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cerned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t of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bjectives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her, one can identify the existence of a dominant peak towards the origin of each plot, indicating that parameters that produce a good fit for one of those objectives tend to produce a good fit for the rest of the objective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existence of Pareto fronts of objectives and Pareto sets of parameters suggested that there were more than one optimal parameter setting for each genotyp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CA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C:\Users\sara.dancom-PC\Pictures\Picture2.jp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200" y="259200"/>
            <a:ext cx="8413200" cy="434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260634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4" y="0"/>
            <a:ext cx="5305245" cy="6858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508104" y="764704"/>
            <a:ext cx="3384376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A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luster diagram of the qualified parameter settings for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-0. 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timizing the 200,000 computer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terations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the 4 sets of objectives such that differences between modeled and measurements for each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leaf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and masses of leaf, inflorescence and root are less than or equal to 1, the identified 84 qualified parameter settings for Col-0 (Supplementary Table 2A)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ed to hierarchical clustering algorithm to categorize these parameter settings as shown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low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each cluster, the most representative and biologically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easibl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 settings were selected manually followed by further selection based on their best fit to leaf area and leaf mass (Supplementary Table 2C, Table 2). 		</a:t>
            </a:r>
          </a:p>
        </p:txBody>
      </p:sp>
    </p:spTree>
    <p:extLst>
      <p:ext uri="{BB962C8B-B14F-4D97-AF65-F5344CB8AC3E}">
        <p14:creationId xmlns:p14="http://schemas.microsoft.com/office/powerpoint/2010/main" val="14244272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600" y="0"/>
            <a:ext cx="5306400" cy="6858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508000" y="763200"/>
            <a:ext cx="3384000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B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luster diagram of the qualified parameter settings for </a:t>
            </a:r>
            <a:r>
              <a:rPr lang="en-CA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-2.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optimizing the 200,000 computer iterations based on the 4 sets of objectives such that differences between modeled and measurements for each of leaf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and masses of leaf, inflorescence and root are less than or equal to 1, the identified 95 qualified parameter settings for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upplementary Table 2B)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subjected to hierarchical clustering algorithm to categorize these parameter settings into groups as shown below. From each cluster, the most representative and biologically feasibl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 settings were selected manually followed by further selection based on their best fit to leaf area and leaf mass (Supplementary Table 2C, Table 2). 															</a:t>
            </a:r>
          </a:p>
        </p:txBody>
      </p:sp>
    </p:spTree>
    <p:extLst>
      <p:ext uri="{BB962C8B-B14F-4D97-AF65-F5344CB8AC3E}">
        <p14:creationId xmlns:p14="http://schemas.microsoft.com/office/powerpoint/2010/main" val="1743378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72000" y="5014800"/>
            <a:ext cx="7200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ed daily values for available C, NAR, and leaf area growth rate over time in Col-0 and </a:t>
            </a:r>
            <a:r>
              <a:rPr lang="en-CA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n available for maintenance, exudation and growth processes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NAR or carbon available for growth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he leaf area growth rate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uring the day and night for Col-0 and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presented. Modeled data were generated using learned partition coefficients listed under simulation 1 (Table 2). Col-0 day time (open circles) and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y time (open squares) and during the night for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-0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otted lines) and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-2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illed squares) is simulated from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to 90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S. </a:t>
            </a:r>
          </a:p>
        </p:txBody>
      </p:sp>
      <p:pic>
        <p:nvPicPr>
          <p:cNvPr id="1026" name="Picture 2" descr="C:\Users\sara.dancom-PC\Desktop\Figure 4.jp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3600" y="259200"/>
            <a:ext cx="5716800" cy="434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17744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1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1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5B0827CF-1447-4A96-9236-FEE94C5E06EB}"/>
</file>

<file path=customXml/itemProps2.xml><?xml version="1.0" encoding="utf-8"?>
<ds:datastoreItem xmlns:ds="http://schemas.openxmlformats.org/officeDocument/2006/customXml" ds:itemID="{CA4CE282-8774-4B20-BCBA-9EF5AD8EC629}"/>
</file>

<file path=customXml/itemProps3.xml><?xml version="1.0" encoding="utf-8"?>
<ds:datastoreItem xmlns:ds="http://schemas.openxmlformats.org/officeDocument/2006/customXml" ds:itemID="{149EE3F5-DAC2-4771-A8A4-1ED5F29FEC1C}"/>
</file>

<file path=docProps/app.xml><?xml version="1.0" encoding="utf-8"?>
<Properties xmlns="http://schemas.openxmlformats.org/officeDocument/2006/extended-properties" xmlns:vt="http://schemas.openxmlformats.org/officeDocument/2006/docPropsVTypes">
  <TotalTime>523</TotalTime>
  <Words>965</Words>
  <Application>Microsoft Office PowerPoint</Application>
  <PresentationFormat>On-screen Show (4:3)</PresentationFormat>
  <Paragraphs>7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</dc:creator>
  <cp:lastModifiedBy>sara</cp:lastModifiedBy>
  <cp:revision>44</cp:revision>
  <dcterms:created xsi:type="dcterms:W3CDTF">2014-12-08T23:46:19Z</dcterms:created>
  <dcterms:modified xsi:type="dcterms:W3CDTF">2015-02-15T21:55:49Z</dcterms:modified>
</cp:coreProperties>
</file>